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056" y="-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30819-9A2A-4877-9AAD-2E8AFEF619F9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27257-14AF-4150-A181-FD5B4CC813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30819-9A2A-4877-9AAD-2E8AFEF619F9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27257-14AF-4150-A181-FD5B4CC813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30819-9A2A-4877-9AAD-2E8AFEF619F9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27257-14AF-4150-A181-FD5B4CC813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30819-9A2A-4877-9AAD-2E8AFEF619F9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27257-14AF-4150-A181-FD5B4CC813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30819-9A2A-4877-9AAD-2E8AFEF619F9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27257-14AF-4150-A181-FD5B4CC813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30819-9A2A-4877-9AAD-2E8AFEF619F9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27257-14AF-4150-A181-FD5B4CC813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30819-9A2A-4877-9AAD-2E8AFEF619F9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27257-14AF-4150-A181-FD5B4CC813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30819-9A2A-4877-9AAD-2E8AFEF619F9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27257-14AF-4150-A181-FD5B4CC813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30819-9A2A-4877-9AAD-2E8AFEF619F9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27257-14AF-4150-A181-FD5B4CC813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30819-9A2A-4877-9AAD-2E8AFEF619F9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27257-14AF-4150-A181-FD5B4CC813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30819-9A2A-4877-9AAD-2E8AFEF619F9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27257-14AF-4150-A181-FD5B4CC813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030819-9A2A-4877-9AAD-2E8AFEF619F9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227257-14AF-4150-A181-FD5B4CC81353}" type="slidenum">
              <a:rPr lang="en-IN" smtClean="0"/>
              <a:pPr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new final figure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4400" y="0"/>
            <a:ext cx="4648200" cy="3114294"/>
          </a:xfrm>
          <a:prstGeom prst="rect">
            <a:avLst/>
          </a:prstGeom>
        </p:spPr>
      </p:pic>
      <p:pic>
        <p:nvPicPr>
          <p:cNvPr id="3" name="Picture 2" descr="splice variants.pn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14400" y="3124200"/>
            <a:ext cx="4648200" cy="1440942"/>
          </a:xfrm>
          <a:prstGeom prst="rect">
            <a:avLst/>
          </a:prstGeom>
        </p:spPr>
      </p:pic>
      <p:pic>
        <p:nvPicPr>
          <p:cNvPr id="4" name="Picture 3" descr="rice protein structure.png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4400" y="4572000"/>
            <a:ext cx="4648200" cy="348615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533400" y="8128337"/>
            <a:ext cx="5867400" cy="1015663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7 Fig.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Gene structure, splice variants and domain organization of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Oryza sativa FLZ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family.</a:t>
            </a:r>
          </a:p>
          <a:p>
            <a:pPr algn="just"/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(A) Gene structure of 29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O. sativa FLZ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genes showing exon, intron and UTR organization. (B) Alternative transcripts of 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O. sativa FLZ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genes .(C) Domain organization of 33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O. sativ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FLZ proteins.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85800" y="0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</a:t>
            </a:r>
            <a:endParaRPr lang="en-US" sz="12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685800" y="3162300"/>
            <a:ext cx="2712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B</a:t>
            </a:r>
            <a:endParaRPr lang="en-US" sz="12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736600" y="4572000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C</a:t>
            </a:r>
            <a:endParaRPr lang="en-US" sz="12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4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r.A Laxmi-203</dc:creator>
  <cp:lastModifiedBy>Dr.A Laxmi-203</cp:lastModifiedBy>
  <cp:revision>2</cp:revision>
  <dcterms:created xsi:type="dcterms:W3CDTF">2015-07-04T15:00:43Z</dcterms:created>
  <dcterms:modified xsi:type="dcterms:W3CDTF">2015-07-16T11:22:48Z</dcterms:modified>
</cp:coreProperties>
</file>